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0"/>
    <p:restoredTop sz="94628"/>
  </p:normalViewPr>
  <p:slideViewPr>
    <p:cSldViewPr snapToGrid="0" snapToObjects="1" showGuides="1">
      <p:cViewPr varScale="1">
        <p:scale>
          <a:sx n="113" d="100"/>
          <a:sy n="113" d="100"/>
        </p:scale>
        <p:origin x="192" y="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lavio Tomasella" userId="033cc24b-48c5-44da-ad46-f6e782fcdeca" providerId="ADAL" clId="{B5334F9B-3B7C-45A0-B3ED-6AA283381E99}"/>
    <pc:docChg chg="modSld">
      <pc:chgData name="Flavio Tomasella" userId="033cc24b-48c5-44da-ad46-f6e782fcdeca" providerId="ADAL" clId="{B5334F9B-3B7C-45A0-B3ED-6AA283381E99}" dt="2023-12-19T14:59:23.491" v="8" actId="207"/>
      <pc:docMkLst>
        <pc:docMk/>
      </pc:docMkLst>
      <pc:sldChg chg="modSp mod">
        <pc:chgData name="Flavio Tomasella" userId="033cc24b-48c5-44da-ad46-f6e782fcdeca" providerId="ADAL" clId="{B5334F9B-3B7C-45A0-B3ED-6AA283381E99}" dt="2023-12-19T14:59:23.491" v="8" actId="207"/>
        <pc:sldMkLst>
          <pc:docMk/>
          <pc:sldMk cId="4112225143" sldId="258"/>
        </pc:sldMkLst>
        <pc:spChg chg="mod">
          <ac:chgData name="Flavio Tomasella" userId="033cc24b-48c5-44da-ad46-f6e782fcdeca" providerId="ADAL" clId="{B5334F9B-3B7C-45A0-B3ED-6AA283381E99}" dt="2023-12-19T14:58:43.291" v="1" actId="207"/>
          <ac:spMkLst>
            <pc:docMk/>
            <pc:sldMk cId="4112225143" sldId="258"/>
            <ac:spMk id="2" creationId="{ED89105A-73E0-5D40-A683-58871246509A}"/>
          </ac:spMkLst>
        </pc:spChg>
        <pc:spChg chg="mod">
          <ac:chgData name="Flavio Tomasella" userId="033cc24b-48c5-44da-ad46-f6e782fcdeca" providerId="ADAL" clId="{B5334F9B-3B7C-45A0-B3ED-6AA283381E99}" dt="2023-12-19T14:59:23.491" v="8" actId="207"/>
          <ac:spMkLst>
            <pc:docMk/>
            <pc:sldMk cId="4112225143" sldId="258"/>
            <ac:spMk id="7" creationId="{81957893-866A-F24D-AAAF-513C9DF45FEC}"/>
          </ac:spMkLst>
        </pc:spChg>
        <pc:spChg chg="mod">
          <ac:chgData name="Flavio Tomasella" userId="033cc24b-48c5-44da-ad46-f6e782fcdeca" providerId="ADAL" clId="{B5334F9B-3B7C-45A0-B3ED-6AA283381E99}" dt="2023-12-19T14:58:55.774" v="5" actId="207"/>
          <ac:spMkLst>
            <pc:docMk/>
            <pc:sldMk cId="4112225143" sldId="258"/>
            <ac:spMk id="9" creationId="{6E0DA03C-6F96-9F4F-945B-8EE3E544CAB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F821E2-B1BE-3441-BA53-D413CB3EE4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187EF8E-321E-2E46-9ECF-585DCBDE12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94D086-9AA6-3643-B1F3-5AF95FF66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7124B4-F67E-A444-8F07-A6F6648C8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0A4CCC-0EBC-D245-99DC-4F59E852A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91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6269CB-0410-1A4B-B936-A9CE909E59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C689B6-EC09-3A41-A262-1F0278DC87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E69C90-EC5B-7242-B1A2-A972EF8E3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62FAB8-A8FD-BD4B-8097-2C68A80A4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1BC267-D02A-2D4B-B3F2-F10810D25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9212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0F13A40-2B35-0448-874A-777D41D539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751F10F-5803-A94B-8449-6C37DE6799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C3043B-5D08-1543-8AD1-C4DEF2FBE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91140B-4511-C646-AD2B-244662F3B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0843D8-A285-7E45-A92F-E9FB53514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516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8151AD-FDD8-024E-BA55-DA93B3E73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CB03E4D-1927-7841-84C1-9B14F653B1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E7411E-5E9D-0041-8BBA-D80A83CF5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EBF17B-F85C-D44C-94D0-5B730B58A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1D0BE0-D110-4948-856A-F3B25B5EA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5715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27A647-FEFA-6840-80D9-E0598170A5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8DA772-6D12-C446-B1E4-7FF5781D53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19F4DB-D579-7741-9512-A3A35208D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078BA7-3AEE-1D41-9E56-4F54E6166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C6EC5E-2603-154A-96FC-5E8802FA2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805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BF0E2E-9E9A-DA48-A632-A825DCE49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D815CC-B181-9B48-A4EE-7E14AC89BF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34282AF-0DB0-2543-8237-ED71D14CDE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857B3C-0FCD-004E-A614-030DB60EE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1E19382-17C9-F742-B115-DFC709A53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F982EFD-D593-C640-AACC-B3C3D5466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08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2C4BB1-8F51-AB49-8150-460759CFC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23D62B-108F-E849-A8F9-2AB0AB1AA8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C4521F8-A16B-D04C-96A3-6624D3DDB9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ED8A3DF-5200-E947-BFE9-82E84F0425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4835BB2-6A56-D44B-A925-1949B52DFE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D6C96F1-6696-6344-AAC3-039587A91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22798B1-778D-244D-BA6C-9E6FF7431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D00C7A4-DA6C-A445-A5CB-C59F724EF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807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616D77-CD3C-0248-B9C1-B675778B4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D59B810-A5F8-6845-8FD7-9354ADFF9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609D9FD-B0C7-DE43-AE9F-EA34B181F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7CC3DBF-B81E-6C4D-98B6-3A624AA7D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476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505307A-3486-3442-9884-6129CC96D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EF8123-024D-C14A-A315-964E7E0C7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8C0E0EF-652F-4D44-8522-FF544E76B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816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EB2039-3E25-7D4C-AE54-F6F29D114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D55122C-B8F4-3F48-89BA-158590BC78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197BE97-9F49-9F4D-841E-8198BC1DCF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410B2F0-1958-3349-A510-75872FEBA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2E1050-7E30-7D47-A95E-E2E46E19C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9D42D7E-1855-B542-BF23-763D7CB96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142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6F199D-33C7-1749-863F-D9B6C9BA9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8C45FF3-E5DB-9F40-B12F-343FE5B6C0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B5261A-BF6B-AD47-9D0B-9171ECA941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EEF2B03-E210-5641-8BA8-7E4A745FA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9C4B19C-3E44-A145-8475-9CCC87A18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5197FF-AA87-9B44-9AAD-D5D69B15A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4058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CDD3D25-D8E9-6E49-8575-F9317FA305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E4DE40-E8A4-2243-9B28-41107D4DD2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E51309-5BB8-6D41-B7E0-8393627C04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44DFD-7EDD-DA4A-813C-3EECB2DDBD25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C544B3-772B-994C-91B2-25B59B8825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6D4554-6FD5-8F40-9186-C5B9FD4420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B9430-2626-C040-B881-6E26F5367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219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0F6E72E-637C-3A4F-9418-BB8242F554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605" y="839611"/>
            <a:ext cx="5178777" cy="517877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D89105A-73E0-5D40-A683-58871246509A}"/>
              </a:ext>
            </a:extLst>
          </p:cNvPr>
          <p:cNvSpPr txBox="1"/>
          <p:nvPr/>
        </p:nvSpPr>
        <p:spPr>
          <a:xfrm>
            <a:off x="1862670" y="1377243"/>
            <a:ext cx="33202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nonlinearity = 0.24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0EA37D1-007B-CB4D-9BE3-98F4A85BA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3326" y="839611"/>
            <a:ext cx="5287433" cy="520841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1957893-866A-F24D-AAAF-513C9DF45FEC}"/>
              </a:ext>
            </a:extLst>
          </p:cNvPr>
          <p:cNvSpPr txBox="1"/>
          <p:nvPr/>
        </p:nvSpPr>
        <p:spPr>
          <a:xfrm>
            <a:off x="7682092" y="1377243"/>
            <a:ext cx="33202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nonlinearity = 0.38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C414FE9-11D8-444E-970E-63658128C499}"/>
              </a:ext>
            </a:extLst>
          </p:cNvPr>
          <p:cNvSpPr txBox="1"/>
          <p:nvPr/>
        </p:nvSpPr>
        <p:spPr>
          <a:xfrm>
            <a:off x="2517427" y="5756778"/>
            <a:ext cx="232833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ical Apgar score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E8BA846-D7D7-724E-B8BE-14619C83402C}"/>
              </a:ext>
            </a:extLst>
          </p:cNvPr>
          <p:cNvSpPr txBox="1"/>
          <p:nvPr/>
        </p:nvSpPr>
        <p:spPr>
          <a:xfrm>
            <a:off x="8336849" y="5756778"/>
            <a:ext cx="232833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ical Apgar score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0DA03C-6F96-9F4F-945B-8EE3E544CAB8}"/>
              </a:ext>
            </a:extLst>
          </p:cNvPr>
          <p:cNvSpPr txBox="1"/>
          <p:nvPr/>
        </p:nvSpPr>
        <p:spPr>
          <a:xfrm>
            <a:off x="234052" y="1503608"/>
            <a:ext cx="800219" cy="3850784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0"/>
            </a:camera>
            <a:lightRig rig="threePt" dir="t"/>
          </a:scene3d>
        </p:spPr>
        <p:txBody>
          <a:bodyPr vert="vert270"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ce of complications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≥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lavien-Dindo classification  3</a:t>
            </a:r>
            <a:r>
              <a:rPr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73A78D9-50C8-FD43-A9D0-090C0239C967}"/>
              </a:ext>
            </a:extLst>
          </p:cNvPr>
          <p:cNvSpPr txBox="1"/>
          <p:nvPr/>
        </p:nvSpPr>
        <p:spPr>
          <a:xfrm>
            <a:off x="6321704" y="1777353"/>
            <a:ext cx="492443" cy="3014608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of postoperative stay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2225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8</Words>
  <Application>Microsoft Macintosh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位田 みつる</dc:creator>
  <cp:lastModifiedBy>位田 みつる</cp:lastModifiedBy>
  <cp:revision>6</cp:revision>
  <dcterms:created xsi:type="dcterms:W3CDTF">2023-05-19T05:03:16Z</dcterms:created>
  <dcterms:modified xsi:type="dcterms:W3CDTF">2023-12-29T07:29:47Z</dcterms:modified>
</cp:coreProperties>
</file>